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</p:sldIdLst>
  <p:sldSz cx="6858000" cy="9144000" type="screen4x3"/>
  <p:notesSz cx="6797675" cy="9928225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49" d="100"/>
          <a:sy n="49" d="100"/>
        </p:scale>
        <p:origin x="2256" y="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8ED15-4E9B-4B9F-AFCB-2627E28E1A8F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A68CF-FF24-4F60-9E63-DE896F3752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43382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8ED15-4E9B-4B9F-AFCB-2627E28E1A8F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A68CF-FF24-4F60-9E63-DE896F3752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03639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8ED15-4E9B-4B9F-AFCB-2627E28E1A8F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A68CF-FF24-4F60-9E63-DE896F3752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12196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8ED15-4E9B-4B9F-AFCB-2627E28E1A8F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A68CF-FF24-4F60-9E63-DE896F3752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36672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8ED15-4E9B-4B9F-AFCB-2627E28E1A8F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A68CF-FF24-4F60-9E63-DE896F3752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949519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8ED15-4E9B-4B9F-AFCB-2627E28E1A8F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A68CF-FF24-4F60-9E63-DE896F3752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42769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8ED15-4E9B-4B9F-AFCB-2627E28E1A8F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A68CF-FF24-4F60-9E63-DE896F3752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48155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8ED15-4E9B-4B9F-AFCB-2627E28E1A8F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A68CF-FF24-4F60-9E63-DE896F3752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959393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8ED15-4E9B-4B9F-AFCB-2627E28E1A8F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A68CF-FF24-4F60-9E63-DE896F3752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090434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8ED15-4E9B-4B9F-AFCB-2627E28E1A8F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A68CF-FF24-4F60-9E63-DE896F3752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491822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8ED15-4E9B-4B9F-AFCB-2627E28E1A8F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1A68CF-FF24-4F60-9E63-DE896F3752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551169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28ED15-4E9B-4B9F-AFCB-2627E28E1A8F}" type="datetimeFigureOut">
              <a:rPr lang="fr-FR" smtClean="0"/>
              <a:t>01/11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1A68CF-FF24-4F60-9E63-DE896F3752B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086080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Image 24">
            <a:extLst>
              <a:ext uri="{FF2B5EF4-FFF2-40B4-BE49-F238E27FC236}">
                <a16:creationId xmlns:a16="http://schemas.microsoft.com/office/drawing/2014/main" id="{E05C2424-C02A-44CC-A87A-27BCBF0ECD2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6632" y="0"/>
            <a:ext cx="6381328" cy="3359423"/>
          </a:xfrm>
          <a:prstGeom prst="rect">
            <a:avLst/>
          </a:prstGeom>
        </p:spPr>
      </p:pic>
      <p:pic>
        <p:nvPicPr>
          <p:cNvPr id="27" name="Image 26">
            <a:extLst>
              <a:ext uri="{FF2B5EF4-FFF2-40B4-BE49-F238E27FC236}">
                <a16:creationId xmlns:a16="http://schemas.microsoft.com/office/drawing/2014/main" id="{086B7B47-ED14-42F5-93C9-DA6CE68AA39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4516" y="3297540"/>
            <a:ext cx="6597352" cy="1812221"/>
          </a:xfrm>
          <a:prstGeom prst="rect">
            <a:avLst/>
          </a:prstGeom>
        </p:spPr>
      </p:pic>
      <p:pic>
        <p:nvPicPr>
          <p:cNvPr id="28" name="Image 27">
            <a:extLst>
              <a:ext uri="{FF2B5EF4-FFF2-40B4-BE49-F238E27FC236}">
                <a16:creationId xmlns:a16="http://schemas.microsoft.com/office/drawing/2014/main" id="{4B3B5EE0-E898-434D-AEBE-8BEBF8A128F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4516" y="5076056"/>
            <a:ext cx="6597352" cy="1832598"/>
          </a:xfrm>
          <a:prstGeom prst="rect">
            <a:avLst/>
          </a:prstGeom>
        </p:spPr>
      </p:pic>
      <p:pic>
        <p:nvPicPr>
          <p:cNvPr id="29" name="Image 28">
            <a:extLst>
              <a:ext uri="{FF2B5EF4-FFF2-40B4-BE49-F238E27FC236}">
                <a16:creationId xmlns:a16="http://schemas.microsoft.com/office/drawing/2014/main" id="{052C4D68-D775-4616-9C9A-36FB9EC18C5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4516" y="6908654"/>
            <a:ext cx="6597352" cy="16987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661780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16632" y="467544"/>
            <a:ext cx="6480720" cy="14501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2: Natural variation of North African barley responses to N </a:t>
            </a:r>
            <a:r>
              <a:rPr lang="en-US" sz="1000" b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y </a:t>
            </a:r>
            <a:r>
              <a:rPr lang="en-US" sz="1000" b="1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llustrated by  </a:t>
            </a: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hysiological traits.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ean values of indicated traits under HN are plotted against mean values under LN. Four independent experiments were performed. Stars indicate significant difference between LN and HN (Student’s test, 13 ≤ n ≤ 16, p &lt; 0.05). Bars represent SE. The strait line represents the Y=X curve. Colors of the dots correspond to the classes defined in Figure 1. 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endParaRPr lang="en-US" sz="1000" b="1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fr-FR" sz="10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0673910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54</TotalTime>
  <Words>88</Words>
  <Application>Microsoft Office PowerPoint</Application>
  <PresentationFormat>Affichage à l'écran (4:3)</PresentationFormat>
  <Paragraphs>3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5" baseType="lpstr">
      <vt:lpstr>Arial</vt:lpstr>
      <vt:lpstr>Calibri</vt:lpstr>
      <vt:lpstr>Thème Office</vt:lpstr>
      <vt:lpstr>Présentation PowerPoint</vt:lpstr>
      <vt:lpstr>Présentation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ia</dc:creator>
  <cp:lastModifiedBy>Alia Dellagi</cp:lastModifiedBy>
  <cp:revision>37</cp:revision>
  <cp:lastPrinted>2021-01-19T09:00:54Z</cp:lastPrinted>
  <dcterms:created xsi:type="dcterms:W3CDTF">2021-01-19T08:45:23Z</dcterms:created>
  <dcterms:modified xsi:type="dcterms:W3CDTF">2021-11-01T19:17:33Z</dcterms:modified>
</cp:coreProperties>
</file>